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1" r:id="rId2"/>
  </p:sldIdLst>
  <p:sldSz cx="7920038" cy="46799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840"/>
  </p:normalViewPr>
  <p:slideViewPr>
    <p:cSldViewPr snapToGrid="0">
      <p:cViewPr varScale="1">
        <p:scale>
          <a:sx n="165" d="100"/>
          <a:sy n="165" d="100"/>
        </p:scale>
        <p:origin x="75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92608B-0DD9-AF46-A96C-6DB2B6557D8E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817563" y="1143000"/>
            <a:ext cx="52228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5C7FFD-6552-1F47-812C-0C2A67AC8B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66803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1pPr>
    <a:lvl2pPr marL="302356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2pPr>
    <a:lvl3pPr marL="604712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3pPr>
    <a:lvl4pPr marL="907068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4pPr>
    <a:lvl5pPr marL="1209425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5pPr>
    <a:lvl6pPr marL="1511780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6pPr>
    <a:lvl7pPr marL="1814136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7pPr>
    <a:lvl8pPr marL="2116492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8pPr>
    <a:lvl9pPr marL="2418849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90005" y="765909"/>
            <a:ext cx="5940029" cy="1629316"/>
          </a:xfrm>
        </p:spPr>
        <p:txBody>
          <a:bodyPr anchor="b"/>
          <a:lstStyle>
            <a:lvl1pPr algn="ctr">
              <a:defRPr sz="389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90005" y="2458058"/>
            <a:ext cx="5940029" cy="1129904"/>
          </a:xfrm>
        </p:spPr>
        <p:txBody>
          <a:bodyPr/>
          <a:lstStyle>
            <a:lvl1pPr marL="0" indent="0" algn="ctr">
              <a:buNone/>
              <a:defRPr sz="1559"/>
            </a:lvl1pPr>
            <a:lvl2pPr marL="296997" indent="0" algn="ctr">
              <a:buNone/>
              <a:defRPr sz="1299"/>
            </a:lvl2pPr>
            <a:lvl3pPr marL="593994" indent="0" algn="ctr">
              <a:buNone/>
              <a:defRPr sz="1169"/>
            </a:lvl3pPr>
            <a:lvl4pPr marL="890991" indent="0" algn="ctr">
              <a:buNone/>
              <a:defRPr sz="1039"/>
            </a:lvl4pPr>
            <a:lvl5pPr marL="1187988" indent="0" algn="ctr">
              <a:buNone/>
              <a:defRPr sz="1039"/>
            </a:lvl5pPr>
            <a:lvl6pPr marL="1484986" indent="0" algn="ctr">
              <a:buNone/>
              <a:defRPr sz="1039"/>
            </a:lvl6pPr>
            <a:lvl7pPr marL="1781983" indent="0" algn="ctr">
              <a:buNone/>
              <a:defRPr sz="1039"/>
            </a:lvl7pPr>
            <a:lvl8pPr marL="2078980" indent="0" algn="ctr">
              <a:buNone/>
              <a:defRPr sz="1039"/>
            </a:lvl8pPr>
            <a:lvl9pPr marL="2375977" indent="0" algn="ctr">
              <a:buNone/>
              <a:defRPr sz="1039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3178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2605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67777" y="249164"/>
            <a:ext cx="1707758" cy="3966041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44503" y="249164"/>
            <a:ext cx="5024274" cy="3966041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83997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9292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0377" y="1166738"/>
            <a:ext cx="6831033" cy="1946729"/>
          </a:xfrm>
        </p:spPr>
        <p:txBody>
          <a:bodyPr anchor="b"/>
          <a:lstStyle>
            <a:lvl1pPr>
              <a:defRPr sz="389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0377" y="3131884"/>
            <a:ext cx="6831033" cy="1023739"/>
          </a:xfrm>
        </p:spPr>
        <p:txBody>
          <a:bodyPr/>
          <a:lstStyle>
            <a:lvl1pPr marL="0" indent="0">
              <a:buNone/>
              <a:defRPr sz="1559">
                <a:solidFill>
                  <a:schemeClr val="tx1">
                    <a:tint val="75000"/>
                  </a:schemeClr>
                </a:solidFill>
              </a:defRPr>
            </a:lvl1pPr>
            <a:lvl2pPr marL="296997" indent="0">
              <a:buNone/>
              <a:defRPr sz="1299">
                <a:solidFill>
                  <a:schemeClr val="tx1">
                    <a:tint val="75000"/>
                  </a:schemeClr>
                </a:solidFill>
              </a:defRPr>
            </a:lvl2pPr>
            <a:lvl3pPr marL="593994" indent="0">
              <a:buNone/>
              <a:defRPr sz="1169">
                <a:solidFill>
                  <a:schemeClr val="tx1">
                    <a:tint val="75000"/>
                  </a:schemeClr>
                </a:solidFill>
              </a:defRPr>
            </a:lvl3pPr>
            <a:lvl4pPr marL="890991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4pPr>
            <a:lvl5pPr marL="1187988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5pPr>
            <a:lvl6pPr marL="1484986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6pPr>
            <a:lvl7pPr marL="1781983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7pPr>
            <a:lvl8pPr marL="2078980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8pPr>
            <a:lvl9pPr marL="2375977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32155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44503" y="1245820"/>
            <a:ext cx="3366016" cy="296938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009519" y="1245820"/>
            <a:ext cx="3366016" cy="296938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69634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249164"/>
            <a:ext cx="6831033" cy="90457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5535" y="1147238"/>
            <a:ext cx="3350547" cy="562244"/>
          </a:xfrm>
        </p:spPr>
        <p:txBody>
          <a:bodyPr anchor="b"/>
          <a:lstStyle>
            <a:lvl1pPr marL="0" indent="0">
              <a:buNone/>
              <a:defRPr sz="1559" b="1"/>
            </a:lvl1pPr>
            <a:lvl2pPr marL="296997" indent="0">
              <a:buNone/>
              <a:defRPr sz="1299" b="1"/>
            </a:lvl2pPr>
            <a:lvl3pPr marL="593994" indent="0">
              <a:buNone/>
              <a:defRPr sz="1169" b="1"/>
            </a:lvl3pPr>
            <a:lvl4pPr marL="890991" indent="0">
              <a:buNone/>
              <a:defRPr sz="1039" b="1"/>
            </a:lvl4pPr>
            <a:lvl5pPr marL="1187988" indent="0">
              <a:buNone/>
              <a:defRPr sz="1039" b="1"/>
            </a:lvl5pPr>
            <a:lvl6pPr marL="1484986" indent="0">
              <a:buNone/>
              <a:defRPr sz="1039" b="1"/>
            </a:lvl6pPr>
            <a:lvl7pPr marL="1781983" indent="0">
              <a:buNone/>
              <a:defRPr sz="1039" b="1"/>
            </a:lvl7pPr>
            <a:lvl8pPr marL="2078980" indent="0">
              <a:buNone/>
              <a:defRPr sz="1039" b="1"/>
            </a:lvl8pPr>
            <a:lvl9pPr marL="2375977" indent="0">
              <a:buNone/>
              <a:defRPr sz="1039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5535" y="1709482"/>
            <a:ext cx="3350547" cy="251439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009519" y="1147238"/>
            <a:ext cx="3367048" cy="562244"/>
          </a:xfrm>
        </p:spPr>
        <p:txBody>
          <a:bodyPr anchor="b"/>
          <a:lstStyle>
            <a:lvl1pPr marL="0" indent="0">
              <a:buNone/>
              <a:defRPr sz="1559" b="1"/>
            </a:lvl1pPr>
            <a:lvl2pPr marL="296997" indent="0">
              <a:buNone/>
              <a:defRPr sz="1299" b="1"/>
            </a:lvl2pPr>
            <a:lvl3pPr marL="593994" indent="0">
              <a:buNone/>
              <a:defRPr sz="1169" b="1"/>
            </a:lvl3pPr>
            <a:lvl4pPr marL="890991" indent="0">
              <a:buNone/>
              <a:defRPr sz="1039" b="1"/>
            </a:lvl4pPr>
            <a:lvl5pPr marL="1187988" indent="0">
              <a:buNone/>
              <a:defRPr sz="1039" b="1"/>
            </a:lvl5pPr>
            <a:lvl6pPr marL="1484986" indent="0">
              <a:buNone/>
              <a:defRPr sz="1039" b="1"/>
            </a:lvl6pPr>
            <a:lvl7pPr marL="1781983" indent="0">
              <a:buNone/>
              <a:defRPr sz="1039" b="1"/>
            </a:lvl7pPr>
            <a:lvl8pPr marL="2078980" indent="0">
              <a:buNone/>
              <a:defRPr sz="1039" b="1"/>
            </a:lvl8pPr>
            <a:lvl9pPr marL="2375977" indent="0">
              <a:buNone/>
              <a:defRPr sz="1039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009519" y="1709482"/>
            <a:ext cx="3367048" cy="251439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49058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27475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49146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5" y="311997"/>
            <a:ext cx="2554418" cy="1091988"/>
          </a:xfrm>
        </p:spPr>
        <p:txBody>
          <a:bodyPr anchor="b"/>
          <a:lstStyle>
            <a:lvl1pPr>
              <a:defRPr sz="207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67048" y="673826"/>
            <a:ext cx="4009519" cy="3325798"/>
          </a:xfrm>
        </p:spPr>
        <p:txBody>
          <a:bodyPr/>
          <a:lstStyle>
            <a:lvl1pPr>
              <a:defRPr sz="2079"/>
            </a:lvl1pPr>
            <a:lvl2pPr>
              <a:defRPr sz="1819"/>
            </a:lvl2pPr>
            <a:lvl3pPr>
              <a:defRPr sz="1559"/>
            </a:lvl3pPr>
            <a:lvl4pPr>
              <a:defRPr sz="1299"/>
            </a:lvl4pPr>
            <a:lvl5pPr>
              <a:defRPr sz="1299"/>
            </a:lvl5pPr>
            <a:lvl6pPr>
              <a:defRPr sz="1299"/>
            </a:lvl6pPr>
            <a:lvl7pPr>
              <a:defRPr sz="1299"/>
            </a:lvl7pPr>
            <a:lvl8pPr>
              <a:defRPr sz="1299"/>
            </a:lvl8pPr>
            <a:lvl9pPr>
              <a:defRPr sz="1299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5535" y="1403985"/>
            <a:ext cx="2554418" cy="2601056"/>
          </a:xfrm>
        </p:spPr>
        <p:txBody>
          <a:bodyPr/>
          <a:lstStyle>
            <a:lvl1pPr marL="0" indent="0">
              <a:buNone/>
              <a:defRPr sz="1039"/>
            </a:lvl1pPr>
            <a:lvl2pPr marL="296997" indent="0">
              <a:buNone/>
              <a:defRPr sz="909"/>
            </a:lvl2pPr>
            <a:lvl3pPr marL="593994" indent="0">
              <a:buNone/>
              <a:defRPr sz="780"/>
            </a:lvl3pPr>
            <a:lvl4pPr marL="890991" indent="0">
              <a:buNone/>
              <a:defRPr sz="650"/>
            </a:lvl4pPr>
            <a:lvl5pPr marL="1187988" indent="0">
              <a:buNone/>
              <a:defRPr sz="650"/>
            </a:lvl5pPr>
            <a:lvl6pPr marL="1484986" indent="0">
              <a:buNone/>
              <a:defRPr sz="650"/>
            </a:lvl6pPr>
            <a:lvl7pPr marL="1781983" indent="0">
              <a:buNone/>
              <a:defRPr sz="650"/>
            </a:lvl7pPr>
            <a:lvl8pPr marL="2078980" indent="0">
              <a:buNone/>
              <a:defRPr sz="650"/>
            </a:lvl8pPr>
            <a:lvl9pPr marL="2375977" indent="0">
              <a:buNone/>
              <a:defRPr sz="6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76149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5" y="311997"/>
            <a:ext cx="2554418" cy="1091988"/>
          </a:xfrm>
        </p:spPr>
        <p:txBody>
          <a:bodyPr anchor="b"/>
          <a:lstStyle>
            <a:lvl1pPr>
              <a:defRPr sz="207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67048" y="673826"/>
            <a:ext cx="4009519" cy="3325798"/>
          </a:xfrm>
        </p:spPr>
        <p:txBody>
          <a:bodyPr anchor="t"/>
          <a:lstStyle>
            <a:lvl1pPr marL="0" indent="0">
              <a:buNone/>
              <a:defRPr sz="2079"/>
            </a:lvl1pPr>
            <a:lvl2pPr marL="296997" indent="0">
              <a:buNone/>
              <a:defRPr sz="1819"/>
            </a:lvl2pPr>
            <a:lvl3pPr marL="593994" indent="0">
              <a:buNone/>
              <a:defRPr sz="1559"/>
            </a:lvl3pPr>
            <a:lvl4pPr marL="890991" indent="0">
              <a:buNone/>
              <a:defRPr sz="1299"/>
            </a:lvl4pPr>
            <a:lvl5pPr marL="1187988" indent="0">
              <a:buNone/>
              <a:defRPr sz="1299"/>
            </a:lvl5pPr>
            <a:lvl6pPr marL="1484986" indent="0">
              <a:buNone/>
              <a:defRPr sz="1299"/>
            </a:lvl6pPr>
            <a:lvl7pPr marL="1781983" indent="0">
              <a:buNone/>
              <a:defRPr sz="1299"/>
            </a:lvl7pPr>
            <a:lvl8pPr marL="2078980" indent="0">
              <a:buNone/>
              <a:defRPr sz="1299"/>
            </a:lvl8pPr>
            <a:lvl9pPr marL="2375977" indent="0">
              <a:buNone/>
              <a:defRPr sz="1299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5535" y="1403985"/>
            <a:ext cx="2554418" cy="2601056"/>
          </a:xfrm>
        </p:spPr>
        <p:txBody>
          <a:bodyPr/>
          <a:lstStyle>
            <a:lvl1pPr marL="0" indent="0">
              <a:buNone/>
              <a:defRPr sz="1039"/>
            </a:lvl1pPr>
            <a:lvl2pPr marL="296997" indent="0">
              <a:buNone/>
              <a:defRPr sz="909"/>
            </a:lvl2pPr>
            <a:lvl3pPr marL="593994" indent="0">
              <a:buNone/>
              <a:defRPr sz="780"/>
            </a:lvl3pPr>
            <a:lvl4pPr marL="890991" indent="0">
              <a:buNone/>
              <a:defRPr sz="650"/>
            </a:lvl4pPr>
            <a:lvl5pPr marL="1187988" indent="0">
              <a:buNone/>
              <a:defRPr sz="650"/>
            </a:lvl5pPr>
            <a:lvl6pPr marL="1484986" indent="0">
              <a:buNone/>
              <a:defRPr sz="650"/>
            </a:lvl6pPr>
            <a:lvl7pPr marL="1781983" indent="0">
              <a:buNone/>
              <a:defRPr sz="650"/>
            </a:lvl7pPr>
            <a:lvl8pPr marL="2078980" indent="0">
              <a:buNone/>
              <a:defRPr sz="650"/>
            </a:lvl8pPr>
            <a:lvl9pPr marL="2375977" indent="0">
              <a:buNone/>
              <a:defRPr sz="6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68676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44503" y="249164"/>
            <a:ext cx="6831033" cy="90457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4503" y="1245820"/>
            <a:ext cx="6831033" cy="29693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44502" y="4337621"/>
            <a:ext cx="1782009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23513" y="4337621"/>
            <a:ext cx="2673013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93527" y="4337621"/>
            <a:ext cx="1782009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8790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93994" rtl="0" eaLnBrk="1" latinLnBrk="0" hangingPunct="1">
        <a:lnSpc>
          <a:spcPct val="90000"/>
        </a:lnSpc>
        <a:spcBef>
          <a:spcPct val="0"/>
        </a:spcBef>
        <a:buNone/>
        <a:defRPr kumimoji="1" sz="285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48499" indent="-148499" algn="l" defTabSz="593994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kumimoji="1" sz="1819" kern="1200">
          <a:solidFill>
            <a:schemeClr val="tx1"/>
          </a:solidFill>
          <a:latin typeface="+mn-lt"/>
          <a:ea typeface="+mn-ea"/>
          <a:cs typeface="+mn-cs"/>
        </a:defRPr>
      </a:lvl1pPr>
      <a:lvl2pPr marL="445496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559" kern="1200">
          <a:solidFill>
            <a:schemeClr val="tx1"/>
          </a:solidFill>
          <a:latin typeface="+mn-lt"/>
          <a:ea typeface="+mn-ea"/>
          <a:cs typeface="+mn-cs"/>
        </a:defRPr>
      </a:lvl2pPr>
      <a:lvl3pPr marL="742493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299" kern="1200">
          <a:solidFill>
            <a:schemeClr val="tx1"/>
          </a:solidFill>
          <a:latin typeface="+mn-lt"/>
          <a:ea typeface="+mn-ea"/>
          <a:cs typeface="+mn-cs"/>
        </a:defRPr>
      </a:lvl3pPr>
      <a:lvl4pPr marL="1039490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4pPr>
      <a:lvl5pPr marL="1336487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5pPr>
      <a:lvl6pPr marL="1633484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6pPr>
      <a:lvl7pPr marL="1930481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7pPr>
      <a:lvl8pPr marL="2227478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8pPr>
      <a:lvl9pPr marL="2524476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1pPr>
      <a:lvl2pPr marL="296997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2pPr>
      <a:lvl3pPr marL="593994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3pPr>
      <a:lvl4pPr marL="890991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4pPr>
      <a:lvl5pPr marL="1187988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5pPr>
      <a:lvl6pPr marL="1484986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6pPr>
      <a:lvl7pPr marL="1781983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7pPr>
      <a:lvl8pPr marL="2078980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8pPr>
      <a:lvl9pPr marL="2375977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図 30">
            <a:extLst>
              <a:ext uri="{FF2B5EF4-FFF2-40B4-BE49-F238E27FC236}">
                <a16:creationId xmlns:a16="http://schemas.microsoft.com/office/drawing/2014/main" id="{BD69DB89-94FC-D106-4F8B-A39311AEF69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97819" y="1311275"/>
            <a:ext cx="4724400" cy="205740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BE31D9F-9416-D2A1-FBEE-4900528B4E12}"/>
              </a:ext>
            </a:extLst>
          </p:cNvPr>
          <p:cNvSpPr txBox="1"/>
          <p:nvPr/>
        </p:nvSpPr>
        <p:spPr>
          <a:xfrm>
            <a:off x="0" y="3368675"/>
            <a:ext cx="792003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0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2. Effect of </a:t>
            </a:r>
            <a:r>
              <a:rPr lang="en-US" altLang="ja-JP" sz="1000" b="1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RK5 </a:t>
            </a:r>
            <a:r>
              <a:rPr lang="en-US" altLang="ja-JP" sz="10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ilencing on GSC tumorigenesis by different </a:t>
            </a:r>
            <a:r>
              <a:rPr lang="en-US" altLang="ja-JP" sz="1000" b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hRNAs</a:t>
            </a:r>
            <a:r>
              <a:rPr lang="en-US" altLang="ja-JP" sz="10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A and B) Kaplan–Meier survival analysis of mice inoculated with TGS-01 cells infected with sh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RK5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(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= 8).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value was calculated using a log-rank test. (B) Histological analyses of brains dissected at 40 days after intracranial transplantation. Tissue sections were stained with H&amp;E (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= 5, mean ±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.e.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*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&lt; 0.01). Scale bars represent 1 mm (B).</a:t>
            </a:r>
            <a:endParaRPr lang="ja-JP" altLang="ja-JP" sz="10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5076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</TotalTime>
  <Words>95</Words>
  <Application>Microsoft Macintosh PowerPoint</Application>
  <PresentationFormat>ユーザー設定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檜井栄一</dc:creator>
  <cp:lastModifiedBy>檜井栄一</cp:lastModifiedBy>
  <cp:revision>8</cp:revision>
  <dcterms:created xsi:type="dcterms:W3CDTF">2022-12-07T05:00:03Z</dcterms:created>
  <dcterms:modified xsi:type="dcterms:W3CDTF">2023-01-13T02:11:31Z</dcterms:modified>
</cp:coreProperties>
</file>